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6" r:id="rId2"/>
    <p:sldId id="258" r:id="rId3"/>
    <p:sldId id="266" r:id="rId4"/>
    <p:sldId id="298" r:id="rId5"/>
    <p:sldId id="302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B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3" autoAdjust="0"/>
    <p:restoredTop sz="93207" autoAdjust="0"/>
  </p:normalViewPr>
  <p:slideViewPr>
    <p:cSldViewPr snapToGrid="0">
      <p:cViewPr varScale="1">
        <p:scale>
          <a:sx n="55" d="100"/>
          <a:sy n="55" d="100"/>
        </p:scale>
        <p:origin x="300" y="90"/>
      </p:cViewPr>
      <p:guideLst>
        <p:guide orient="horz" pos="1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1892E2-067D-45E3-8CAE-8AB0F1218809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466766-95F4-4F4F-ADD5-31BC9DBD86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639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.</a:t>
            </a:r>
            <a:r>
              <a:rPr lang="en-US" altLang="zh-CN" baseline="0" dirty="0" smtClean="0"/>
              <a:t> </a:t>
            </a:r>
            <a:r>
              <a:rPr lang="en-US" altLang="zh-CN" baseline="0" dirty="0" smtClean="0"/>
              <a:t>2a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959BE9-1C13-4B11-8A31-53820AF5E60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4772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. 1</a:t>
            </a:r>
            <a:endParaRPr lang="zh-CN" altLang="en-US" b="0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466766-95F4-4F4F-ADD5-31BC9DBD860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09379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. </a:t>
            </a:r>
            <a:r>
              <a:rPr lang="en-US" altLang="zh-CN" sz="1200" b="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9</a:t>
            </a:r>
            <a:endParaRPr lang="zh-CN" altLang="en-US" b="0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466766-95F4-4F4F-ADD5-31BC9DBD860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7493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. </a:t>
            </a:r>
            <a:r>
              <a:rPr lang="en-US" altLang="zh-CN" sz="1200" b="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5</a:t>
            </a:r>
            <a:endParaRPr lang="zh-CN" altLang="en-US" b="0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466766-95F4-4F4F-ADD5-31BC9DBD860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5944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. </a:t>
            </a:r>
            <a:r>
              <a:rPr lang="en-US" altLang="zh-CN" sz="1200" b="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4</a:t>
            </a:r>
            <a:endParaRPr lang="zh-CN" altLang="en-US" b="0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466766-95F4-4F4F-ADD5-31BC9DBD860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3566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366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690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395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830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466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652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8306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1232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54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686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917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43DB6-AE91-4922-A55B-626D9AFA8F6D}" type="datetimeFigureOut">
              <a:rPr lang="zh-CN" altLang="en-US" smtClean="0"/>
              <a:t>2022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282D2-6A4D-4D32-A6AB-2DBBFEFAAF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24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6.png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/>
          <p:cNvGrpSpPr/>
          <p:nvPr/>
        </p:nvGrpSpPr>
        <p:grpSpPr>
          <a:xfrm>
            <a:off x="2387333" y="3689374"/>
            <a:ext cx="1765504" cy="1951779"/>
            <a:chOff x="136501" y="2774974"/>
            <a:chExt cx="1765504" cy="1951779"/>
          </a:xfrm>
        </p:grpSpPr>
        <p:grpSp>
          <p:nvGrpSpPr>
            <p:cNvPr id="6" name="组合 5"/>
            <p:cNvGrpSpPr/>
            <p:nvPr/>
          </p:nvGrpSpPr>
          <p:grpSpPr>
            <a:xfrm>
              <a:off x="136501" y="2774974"/>
              <a:ext cx="1765504" cy="1951779"/>
              <a:chOff x="136654" y="1079617"/>
              <a:chExt cx="1667371" cy="1843293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40039" y="1079617"/>
                <a:ext cx="1263986" cy="1843293"/>
              </a:xfrm>
              <a:prstGeom prst="rect">
                <a:avLst/>
              </a:prstGeom>
            </p:spPr>
          </p:pic>
          <p:grpSp>
            <p:nvGrpSpPr>
              <p:cNvPr id="5" name="组合 4"/>
              <p:cNvGrpSpPr/>
              <p:nvPr/>
            </p:nvGrpSpPr>
            <p:grpSpPr>
              <a:xfrm>
                <a:off x="136654" y="1517440"/>
                <a:ext cx="480995" cy="966223"/>
                <a:chOff x="136654" y="1517440"/>
                <a:chExt cx="480995" cy="966223"/>
              </a:xfrm>
            </p:grpSpPr>
            <p:sp>
              <p:nvSpPr>
                <p:cNvPr id="4" name="文本框 3"/>
                <p:cNvSpPr txBox="1"/>
                <p:nvPr/>
              </p:nvSpPr>
              <p:spPr>
                <a:xfrm>
                  <a:off x="303139" y="1517440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文本框 124"/>
                <p:cNvSpPr txBox="1"/>
                <p:nvPr/>
              </p:nvSpPr>
              <p:spPr>
                <a:xfrm>
                  <a:off x="324780" y="229899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文本框 125"/>
                <p:cNvSpPr txBox="1"/>
                <p:nvPr/>
              </p:nvSpPr>
              <p:spPr>
                <a:xfrm>
                  <a:off x="303139" y="2021620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文本框 126"/>
                <p:cNvSpPr txBox="1"/>
                <p:nvPr/>
              </p:nvSpPr>
              <p:spPr>
                <a:xfrm>
                  <a:off x="303139" y="1887190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文本框 127"/>
                <p:cNvSpPr txBox="1"/>
                <p:nvPr/>
              </p:nvSpPr>
              <p:spPr>
                <a:xfrm>
                  <a:off x="303139" y="1653352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文本框 128"/>
                <p:cNvSpPr txBox="1"/>
                <p:nvPr/>
              </p:nvSpPr>
              <p:spPr>
                <a:xfrm>
                  <a:off x="303139" y="1722046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文本框 129"/>
                <p:cNvSpPr txBox="1"/>
                <p:nvPr/>
              </p:nvSpPr>
              <p:spPr>
                <a:xfrm>
                  <a:off x="303139" y="179639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文本框 133"/>
                <p:cNvSpPr txBox="1"/>
                <p:nvPr/>
              </p:nvSpPr>
              <p:spPr>
                <a:xfrm>
                  <a:off x="303139" y="1576381"/>
                  <a:ext cx="297029" cy="1744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文本框 134"/>
                <p:cNvSpPr txBox="1"/>
                <p:nvPr/>
              </p:nvSpPr>
              <p:spPr>
                <a:xfrm>
                  <a:off x="136654" y="1609854"/>
                  <a:ext cx="297029" cy="1744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50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15" name="直接连接符 14"/>
            <p:cNvCxnSpPr/>
            <p:nvPr/>
          </p:nvCxnSpPr>
          <p:spPr>
            <a:xfrm>
              <a:off x="366981" y="3428751"/>
              <a:ext cx="2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44973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428432" y="3163159"/>
            <a:ext cx="5816211" cy="2887916"/>
            <a:chOff x="428432" y="3163159"/>
            <a:chExt cx="5816211" cy="2887916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ED3D148B-F23B-4C09-9491-628E83BE6D0C}"/>
                </a:ext>
              </a:extLst>
            </p:cNvPr>
            <p:cNvSpPr/>
            <p:nvPr/>
          </p:nvSpPr>
          <p:spPr>
            <a:xfrm>
              <a:off x="428432" y="3184978"/>
              <a:ext cx="50755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/>
            </a:p>
          </p:txBody>
        </p:sp>
        <p:grpSp>
          <p:nvGrpSpPr>
            <p:cNvPr id="3" name="组合 2"/>
            <p:cNvGrpSpPr/>
            <p:nvPr/>
          </p:nvGrpSpPr>
          <p:grpSpPr>
            <a:xfrm>
              <a:off x="3445524" y="3440158"/>
              <a:ext cx="2799119" cy="2566463"/>
              <a:chOff x="467667" y="2354787"/>
              <a:chExt cx="2799119" cy="2566463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1036292" y="2354787"/>
                <a:ext cx="2186940" cy="2566463"/>
              </a:xfrm>
              <a:prstGeom prst="rect">
                <a:avLst/>
              </a:prstGeom>
            </p:spPr>
          </p:pic>
          <p:sp>
            <p:nvSpPr>
              <p:cNvPr id="10" name="文本框 9"/>
              <p:cNvSpPr txBox="1"/>
              <p:nvPr/>
            </p:nvSpPr>
            <p:spPr>
              <a:xfrm>
                <a:off x="1503109" y="2407939"/>
                <a:ext cx="486943" cy="3773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838146" y="2407939"/>
                <a:ext cx="486943" cy="3773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2183481" y="2407939"/>
                <a:ext cx="486943" cy="3773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2490257" y="2391621"/>
                <a:ext cx="486943" cy="3773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2853548" y="2394527"/>
                <a:ext cx="413238" cy="3773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" name="组合 3"/>
              <p:cNvGrpSpPr/>
              <p:nvPr/>
            </p:nvGrpSpPr>
            <p:grpSpPr>
              <a:xfrm>
                <a:off x="467667" y="2446804"/>
                <a:ext cx="665185" cy="1630559"/>
                <a:chOff x="467667" y="2446804"/>
                <a:chExt cx="665185" cy="1630559"/>
              </a:xfrm>
            </p:grpSpPr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AA2B44E0-09C1-2D46-8C2C-C35081B7A2E6}"/>
                    </a:ext>
                  </a:extLst>
                </p:cNvPr>
                <p:cNvSpPr txBox="1"/>
                <p:nvPr/>
              </p:nvSpPr>
              <p:spPr>
                <a:xfrm>
                  <a:off x="723426" y="3130209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190</a:t>
                  </a: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FE9D870B-638D-A242-B915-82D3AB0BE762}"/>
                    </a:ext>
                  </a:extLst>
                </p:cNvPr>
                <p:cNvSpPr txBox="1"/>
                <p:nvPr/>
              </p:nvSpPr>
              <p:spPr>
                <a:xfrm>
                  <a:off x="723426" y="2791903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501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0D3E8CD4-04E1-FC41-B15C-07F8FCB80153}"/>
                    </a:ext>
                  </a:extLst>
                </p:cNvPr>
                <p:cNvSpPr txBox="1"/>
                <p:nvPr/>
              </p:nvSpPr>
              <p:spPr>
                <a:xfrm>
                  <a:off x="723426" y="3505641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67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DAEC0D07-712B-CA4E-A345-2BA0FCB4720A}"/>
                    </a:ext>
                  </a:extLst>
                </p:cNvPr>
                <p:cNvSpPr txBox="1"/>
                <p:nvPr/>
              </p:nvSpPr>
              <p:spPr>
                <a:xfrm>
                  <a:off x="723426" y="2942245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353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C14875C8-E96C-9248-ADB5-20A374B72842}"/>
                    </a:ext>
                  </a:extLst>
                </p:cNvPr>
                <p:cNvSpPr txBox="1"/>
                <p:nvPr/>
              </p:nvSpPr>
              <p:spPr>
                <a:xfrm>
                  <a:off x="723426" y="3304508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110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4FB8F015-0CAC-D14C-827E-E77DCE8A8BF2}"/>
                    </a:ext>
                  </a:extLst>
                </p:cNvPr>
                <p:cNvSpPr txBox="1"/>
                <p:nvPr/>
              </p:nvSpPr>
              <p:spPr>
                <a:xfrm>
                  <a:off x="633627" y="2446804"/>
                  <a:ext cx="499225" cy="3773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defTabSz="457200">
                    <a:defRPr/>
                  </a:pPr>
                  <a:r>
                    <a:rPr lang="en-US" altLang="zh-CN" sz="10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bp</a:t>
                  </a:r>
                  <a:endParaRPr lang="zh-CN" altLang="en-US" sz="10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2C084E0B-AE85-F546-879E-1A08A47A5E8C}"/>
                    </a:ext>
                  </a:extLst>
                </p:cNvPr>
                <p:cNvSpPr txBox="1"/>
                <p:nvPr/>
              </p:nvSpPr>
              <p:spPr>
                <a:xfrm>
                  <a:off x="723426" y="3861919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34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0D3E8CD4-04E1-FC41-B15C-07F8FCB80153}"/>
                    </a:ext>
                  </a:extLst>
                </p:cNvPr>
                <p:cNvSpPr txBox="1"/>
                <p:nvPr/>
              </p:nvSpPr>
              <p:spPr>
                <a:xfrm>
                  <a:off x="723426" y="3391341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 smtClean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89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AA2B44E0-09C1-2D46-8C2C-C35081B7A2E6}"/>
                    </a:ext>
                  </a:extLst>
                </p:cNvPr>
                <p:cNvSpPr txBox="1"/>
                <p:nvPr/>
              </p:nvSpPr>
              <p:spPr>
                <a:xfrm>
                  <a:off x="725635" y="3215934"/>
                  <a:ext cx="35779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 smtClean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147</a:t>
                  </a:r>
                  <a:endPara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AA2B44E0-09C1-2D46-8C2C-C35081B7A2E6}"/>
                    </a:ext>
                  </a:extLst>
                </p:cNvPr>
                <p:cNvSpPr txBox="1"/>
                <p:nvPr/>
              </p:nvSpPr>
              <p:spPr>
                <a:xfrm>
                  <a:off x="720872" y="3039720"/>
                  <a:ext cx="35779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 smtClean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147</a:t>
                  </a:r>
                  <a:endPara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DAEC0D07-712B-CA4E-A345-2BA0FCB4720A}"/>
                    </a:ext>
                  </a:extLst>
                </p:cNvPr>
                <p:cNvSpPr txBox="1"/>
                <p:nvPr/>
              </p:nvSpPr>
              <p:spPr>
                <a:xfrm>
                  <a:off x="467667" y="2907320"/>
                  <a:ext cx="35779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 smtClean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404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DAEC0D07-712B-CA4E-A345-2BA0FCB4720A}"/>
                    </a:ext>
                  </a:extLst>
                </p:cNvPr>
                <p:cNvSpPr txBox="1"/>
                <p:nvPr/>
              </p:nvSpPr>
              <p:spPr>
                <a:xfrm>
                  <a:off x="468460" y="2832707"/>
                  <a:ext cx="35779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 defTabSz="457200">
                    <a:defRPr/>
                  </a:pPr>
                  <a:r>
                    <a:rPr lang="en-US" altLang="zh-CN" sz="800" dirty="0" smtClean="0">
                      <a:solidFill>
                        <a:prstClr val="black"/>
                      </a:solidFill>
                      <a:latin typeface="Arial" panose="020B0604020202090204" pitchFamily="34" charset="0"/>
                      <a:ea typeface="等线" panose="02010600030101010101" pitchFamily="2" charset="-122"/>
                      <a:cs typeface="Arial" panose="020B0604020202090204" pitchFamily="34" charset="0"/>
                    </a:rPr>
                    <a:t>489</a:t>
                  </a:r>
                  <a:endParaRPr lang="zh-CN" altLang="en-US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endParaRPr>
                </a:p>
              </p:txBody>
            </p:sp>
          </p:grpSp>
        </p:grp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D80E053-A02C-48D7-8CFF-17E3A21B7603}"/>
                </a:ext>
              </a:extLst>
            </p:cNvPr>
            <p:cNvSpPr txBox="1"/>
            <p:nvPr/>
          </p:nvSpPr>
          <p:spPr>
            <a:xfrm>
              <a:off x="3464705" y="3163159"/>
              <a:ext cx="4756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671908" y="3476992"/>
              <a:ext cx="2477144" cy="2574083"/>
              <a:chOff x="3704713" y="2332968"/>
              <a:chExt cx="2477144" cy="2574083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4024746" y="2332968"/>
                <a:ext cx="2157111" cy="2574083"/>
              </a:xfrm>
              <a:prstGeom prst="rect">
                <a:avLst/>
              </a:prstGeom>
            </p:spPr>
          </p:pic>
          <p:sp>
            <p:nvSpPr>
              <p:cNvPr id="28" name="文本框 27"/>
              <p:cNvSpPr txBox="1"/>
              <p:nvPr/>
            </p:nvSpPr>
            <p:spPr>
              <a:xfrm>
                <a:off x="4524788" y="2348405"/>
                <a:ext cx="487083" cy="377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4859762" y="2348405"/>
                <a:ext cx="487083" cy="377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5234529" y="2335111"/>
                <a:ext cx="487083" cy="377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5628840" y="2332968"/>
                <a:ext cx="413357" cy="377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AA2B44E0-09C1-2D46-8C2C-C35081B7A2E6}"/>
                  </a:ext>
                </a:extLst>
              </p:cNvPr>
              <p:cNvSpPr txBox="1"/>
              <p:nvPr/>
            </p:nvSpPr>
            <p:spPr>
              <a:xfrm>
                <a:off x="3709475" y="3134511"/>
                <a:ext cx="36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190</a:t>
                </a: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FE9D870B-638D-A242-B915-82D3AB0BE762}"/>
                  </a:ext>
                </a:extLst>
              </p:cNvPr>
              <p:cNvSpPr txBox="1"/>
              <p:nvPr/>
            </p:nvSpPr>
            <p:spPr>
              <a:xfrm>
                <a:off x="3709475" y="2705896"/>
                <a:ext cx="36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501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0D3E8CD4-04E1-FC41-B15C-07F8FCB80153}"/>
                  </a:ext>
                </a:extLst>
              </p:cNvPr>
              <p:cNvSpPr txBox="1"/>
              <p:nvPr/>
            </p:nvSpPr>
            <p:spPr>
              <a:xfrm>
                <a:off x="3709475" y="354886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67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DAEC0D07-712B-CA4E-A345-2BA0FCB4720A}"/>
                  </a:ext>
                </a:extLst>
              </p:cNvPr>
              <p:cNvSpPr txBox="1"/>
              <p:nvPr/>
            </p:nvSpPr>
            <p:spPr>
              <a:xfrm>
                <a:off x="3709475" y="2938649"/>
                <a:ext cx="36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353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C14875C8-E96C-9248-ADB5-20A374B72842}"/>
                  </a:ext>
                </a:extLst>
              </p:cNvPr>
              <p:cNvSpPr txBox="1"/>
              <p:nvPr/>
            </p:nvSpPr>
            <p:spPr>
              <a:xfrm>
                <a:off x="3709475" y="3339948"/>
                <a:ext cx="36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110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4FB8F015-0CAC-D14C-827E-E77DCE8A8BF2}"/>
                  </a:ext>
                </a:extLst>
              </p:cNvPr>
              <p:cNvSpPr txBox="1"/>
              <p:nvPr/>
            </p:nvSpPr>
            <p:spPr>
              <a:xfrm>
                <a:off x="3726572" y="2404913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457200">
                  <a:defRPr/>
                </a:pPr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bp</a:t>
                </a:r>
                <a:endParaRPr lang="zh-CN" altLang="en-US" sz="10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2C084E0B-AE85-F546-879E-1A08A47A5E8C}"/>
                  </a:ext>
                </a:extLst>
              </p:cNvPr>
              <p:cNvSpPr txBox="1"/>
              <p:nvPr/>
            </p:nvSpPr>
            <p:spPr>
              <a:xfrm>
                <a:off x="3709475" y="3907410"/>
                <a:ext cx="36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34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FE9D870B-638D-A242-B915-82D3AB0BE762}"/>
                  </a:ext>
                </a:extLst>
              </p:cNvPr>
              <p:cNvSpPr txBox="1"/>
              <p:nvPr/>
            </p:nvSpPr>
            <p:spPr>
              <a:xfrm>
                <a:off x="3711684" y="2786859"/>
                <a:ext cx="3577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 smtClean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489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0D3E8CD4-04E1-FC41-B15C-07F8FCB80153}"/>
                  </a:ext>
                </a:extLst>
              </p:cNvPr>
              <p:cNvSpPr txBox="1"/>
              <p:nvPr/>
            </p:nvSpPr>
            <p:spPr>
              <a:xfrm>
                <a:off x="3709475" y="342503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 smtClean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89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0D3E8CD4-04E1-FC41-B15C-07F8FCB80153}"/>
                  </a:ext>
                </a:extLst>
              </p:cNvPr>
              <p:cNvSpPr txBox="1"/>
              <p:nvPr/>
            </p:nvSpPr>
            <p:spPr>
              <a:xfrm>
                <a:off x="3704713" y="323929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 smtClean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147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AA2B44E0-09C1-2D46-8C2C-C35081B7A2E6}"/>
                  </a:ext>
                </a:extLst>
              </p:cNvPr>
              <p:cNvSpPr txBox="1"/>
              <p:nvPr/>
            </p:nvSpPr>
            <p:spPr>
              <a:xfrm>
                <a:off x="3711684" y="3039261"/>
                <a:ext cx="3577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 smtClean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242</a:t>
                </a:r>
                <a:endParaRPr lang="en-US" altLang="zh-CN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DAEC0D07-712B-CA4E-A345-2BA0FCB4720A}"/>
                  </a:ext>
                </a:extLst>
              </p:cNvPr>
              <p:cNvSpPr txBox="1"/>
              <p:nvPr/>
            </p:nvSpPr>
            <p:spPr>
              <a:xfrm>
                <a:off x="3711684" y="2862449"/>
                <a:ext cx="35779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defTabSz="457200">
                  <a:defRPr/>
                </a:pPr>
                <a:r>
                  <a:rPr lang="en-US" altLang="zh-CN" sz="800" dirty="0" smtClean="0">
                    <a:solidFill>
                      <a:prstClr val="black"/>
                    </a:solidFill>
                    <a:latin typeface="Arial" panose="020B0604020202090204" pitchFamily="34" charset="0"/>
                    <a:ea typeface="等线" panose="02010600030101010101" pitchFamily="2" charset="-122"/>
                    <a:cs typeface="Arial" panose="020B0604020202090204" pitchFamily="34" charset="0"/>
                  </a:rPr>
                  <a:t>404</a:t>
                </a:r>
                <a:endParaRPr lang="zh-CN" altLang="en-US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endParaRPr>
              </a:p>
            </p:txBody>
          </p:sp>
        </p:grpSp>
        <p:cxnSp>
          <p:nvCxnSpPr>
            <p:cNvPr id="22" name="直接连接符 21"/>
            <p:cNvCxnSpPr/>
            <p:nvPr/>
          </p:nvCxnSpPr>
          <p:spPr>
            <a:xfrm>
              <a:off x="3740150" y="4032250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/>
          </p:nvCxnSpPr>
          <p:spPr>
            <a:xfrm>
              <a:off x="3743325" y="4079875"/>
              <a:ext cx="39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84298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组合 101"/>
          <p:cNvGrpSpPr/>
          <p:nvPr/>
        </p:nvGrpSpPr>
        <p:grpSpPr>
          <a:xfrm>
            <a:off x="404166" y="2727580"/>
            <a:ext cx="5923601" cy="2819145"/>
            <a:chOff x="737994" y="2727580"/>
            <a:chExt cx="5923601" cy="2819145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DAEC0D07-712B-CA4E-A345-2BA0FCB4720A}"/>
                </a:ext>
              </a:extLst>
            </p:cNvPr>
            <p:cNvSpPr txBox="1"/>
            <p:nvPr/>
          </p:nvSpPr>
          <p:spPr>
            <a:xfrm>
              <a:off x="4689053" y="3932970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404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AEC0D07-712B-CA4E-A345-2BA0FCB4720A}"/>
                </a:ext>
              </a:extLst>
            </p:cNvPr>
            <p:cNvSpPr txBox="1"/>
            <p:nvPr/>
          </p:nvSpPr>
          <p:spPr>
            <a:xfrm>
              <a:off x="4686844" y="4018696"/>
              <a:ext cx="36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353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>
              <a:off x="3348226" y="2767884"/>
              <a:ext cx="1322761" cy="2771605"/>
              <a:chOff x="1721036" y="2031284"/>
              <a:chExt cx="1322761" cy="2771605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721036" y="2325771"/>
                <a:ext cx="1235919" cy="2477118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/>
            </p:nvSpPr>
            <p:spPr>
              <a:xfrm rot="19800000">
                <a:off x="2114359" y="2031284"/>
                <a:ext cx="609133" cy="240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altLang="zh-CN" sz="1000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i</a:t>
                </a:r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NC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 rot="19800000">
                <a:off x="2500398" y="2075796"/>
                <a:ext cx="543399" cy="240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CNC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 rot="19800000">
                <a:off x="1760478" y="2041066"/>
                <a:ext cx="570006" cy="240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文本框 8"/>
            <p:cNvSpPr txBox="1"/>
            <p:nvPr/>
          </p:nvSpPr>
          <p:spPr>
            <a:xfrm>
              <a:off x="3027811" y="2767886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984163" y="2760265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56360" y="3063449"/>
              <a:ext cx="1138238" cy="2468420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 rot="19800000">
              <a:off x="5732157" y="2727580"/>
              <a:ext cx="609133" cy="240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0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ni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N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 rot="19800000">
              <a:off x="6118196" y="2772092"/>
              <a:ext cx="543399" cy="240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DCN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 rot="19800000">
              <a:off x="5378276" y="2737362"/>
              <a:ext cx="570006" cy="240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87914" y="3063046"/>
              <a:ext cx="1041543" cy="2483679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/>
          </p:nvSpPr>
          <p:spPr>
            <a:xfrm rot="19800000">
              <a:off x="1774387" y="2728142"/>
              <a:ext cx="606077" cy="248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=7.4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 rot="19800000">
              <a:off x="2024740" y="2728142"/>
              <a:ext cx="606077" cy="248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=6.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 rot="19800000">
              <a:off x="2275093" y="2728142"/>
              <a:ext cx="606077" cy="248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=5.5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 rot="19800000">
              <a:off x="1531572" y="2732191"/>
              <a:ext cx="589881" cy="248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168305" y="3200234"/>
              <a:ext cx="478123" cy="217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301816" y="417128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301816" y="398285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301816" y="379642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1301816" y="369816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1243509" y="361616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243509" y="3493703"/>
              <a:ext cx="419816" cy="217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247188" y="2767885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737994" y="3544069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773713" y="3467869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773714" y="3391669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863506" y="3243097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815881" y="331691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A2B44E0-09C1-2D46-8C2C-C35081B7A2E6}"/>
                </a:ext>
              </a:extLst>
            </p:cNvPr>
            <p:cNvSpPr txBox="1"/>
            <p:nvPr/>
          </p:nvSpPr>
          <p:spPr>
            <a:xfrm>
              <a:off x="3047824" y="4260129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47</a:t>
              </a:r>
              <a:endParaRPr lang="en-US" altLang="zh-CN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FE9D870B-638D-A242-B915-82D3AB0BE762}"/>
                </a:ext>
              </a:extLst>
            </p:cNvPr>
            <p:cNvSpPr txBox="1"/>
            <p:nvPr/>
          </p:nvSpPr>
          <p:spPr>
            <a:xfrm>
              <a:off x="3047825" y="395470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501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D3E8CD4-04E1-FC41-B15C-07F8FCB80153}"/>
                </a:ext>
              </a:extLst>
            </p:cNvPr>
            <p:cNvSpPr txBox="1"/>
            <p:nvPr/>
          </p:nvSpPr>
          <p:spPr>
            <a:xfrm>
              <a:off x="2992371" y="4543960"/>
              <a:ext cx="4132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34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DAEC0D07-712B-CA4E-A345-2BA0FCB4720A}"/>
                </a:ext>
              </a:extLst>
            </p:cNvPr>
            <p:cNvSpPr txBox="1"/>
            <p:nvPr/>
          </p:nvSpPr>
          <p:spPr>
            <a:xfrm>
              <a:off x="2720799" y="3991107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353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14875C8-E96C-9248-ADB5-20A374B72842}"/>
                </a:ext>
              </a:extLst>
            </p:cNvPr>
            <p:cNvSpPr txBox="1"/>
            <p:nvPr/>
          </p:nvSpPr>
          <p:spPr>
            <a:xfrm>
              <a:off x="3105532" y="443000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67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AA2B44E0-09C1-2D46-8C2C-C35081B7A2E6}"/>
                </a:ext>
              </a:extLst>
            </p:cNvPr>
            <p:cNvSpPr txBox="1"/>
            <p:nvPr/>
          </p:nvSpPr>
          <p:spPr>
            <a:xfrm>
              <a:off x="4689053" y="4114029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242</a:t>
              </a:r>
              <a:endParaRPr lang="en-US" altLang="zh-CN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E9D870B-638D-A242-B915-82D3AB0BE762}"/>
                </a:ext>
              </a:extLst>
            </p:cNvPr>
            <p:cNvSpPr txBox="1"/>
            <p:nvPr/>
          </p:nvSpPr>
          <p:spPr>
            <a:xfrm>
              <a:off x="5074987" y="4006490"/>
              <a:ext cx="36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501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D3E8CD4-04E1-FC41-B15C-07F8FCB80153}"/>
                </a:ext>
              </a:extLst>
            </p:cNvPr>
            <p:cNvSpPr txBox="1"/>
            <p:nvPr/>
          </p:nvSpPr>
          <p:spPr>
            <a:xfrm>
              <a:off x="5074987" y="4363407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67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 flipH="1">
              <a:off x="1250073" y="3544070"/>
              <a:ext cx="3763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 flipH="1">
              <a:off x="1112760" y="3544070"/>
              <a:ext cx="139695" cy="94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 flipH="1">
              <a:off x="1250073" y="3520873"/>
              <a:ext cx="3739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 flipH="1">
              <a:off x="1109663" y="3497676"/>
              <a:ext cx="5143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flipH="1">
              <a:off x="1250073" y="3474479"/>
              <a:ext cx="3739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flipH="1">
              <a:off x="1333500" y="3451282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>
            <a:xfrm flipH="1">
              <a:off x="1486977" y="3428085"/>
              <a:ext cx="1346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 flipH="1" flipV="1">
              <a:off x="1378760" y="3359083"/>
              <a:ext cx="111904" cy="699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/>
          </p:nvCxnSpPr>
          <p:spPr>
            <a:xfrm flipH="1">
              <a:off x="1112044" y="3522638"/>
              <a:ext cx="138030" cy="444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 flipH="1" flipV="1">
              <a:off x="1189737" y="3378131"/>
              <a:ext cx="144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 flipH="1" flipV="1">
              <a:off x="1145382" y="3438525"/>
              <a:ext cx="108000" cy="3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FE9D870B-638D-A242-B915-82D3AB0BE762}"/>
                </a:ext>
              </a:extLst>
            </p:cNvPr>
            <p:cNvSpPr txBox="1"/>
            <p:nvPr/>
          </p:nvSpPr>
          <p:spPr>
            <a:xfrm>
              <a:off x="3047824" y="4034084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404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70" name="直接连接符 69"/>
            <p:cNvCxnSpPr/>
            <p:nvPr/>
          </p:nvCxnSpPr>
          <p:spPr>
            <a:xfrm flipH="1">
              <a:off x="3148807" y="4206139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/>
            <p:cNvCxnSpPr/>
            <p:nvPr/>
          </p:nvCxnSpPr>
          <p:spPr>
            <a:xfrm flipH="1" flipV="1">
              <a:off x="3007425" y="4097270"/>
              <a:ext cx="14400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/>
          </p:nvCxnSpPr>
          <p:spPr>
            <a:xfrm flipH="1">
              <a:off x="3148807" y="4244239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DAEC0D07-712B-CA4E-A345-2BA0FCB4720A}"/>
                </a:ext>
              </a:extLst>
            </p:cNvPr>
            <p:cNvSpPr txBox="1"/>
            <p:nvPr/>
          </p:nvSpPr>
          <p:spPr>
            <a:xfrm>
              <a:off x="2720799" y="4168907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90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DAEC0D07-712B-CA4E-A345-2BA0FCB4720A}"/>
                </a:ext>
              </a:extLst>
            </p:cNvPr>
            <p:cNvSpPr txBox="1"/>
            <p:nvPr/>
          </p:nvSpPr>
          <p:spPr>
            <a:xfrm>
              <a:off x="2720799" y="4076832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242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75" name="直接连接符 74"/>
            <p:cNvCxnSpPr/>
            <p:nvPr/>
          </p:nvCxnSpPr>
          <p:spPr>
            <a:xfrm flipH="1" flipV="1">
              <a:off x="3007425" y="4171881"/>
              <a:ext cx="144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/>
          </p:nvCxnSpPr>
          <p:spPr>
            <a:xfrm flipH="1">
              <a:off x="3014663" y="4291405"/>
              <a:ext cx="4221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AA2B44E0-09C1-2D46-8C2C-C35081B7A2E6}"/>
                </a:ext>
              </a:extLst>
            </p:cNvPr>
            <p:cNvSpPr txBox="1"/>
            <p:nvPr/>
          </p:nvSpPr>
          <p:spPr>
            <a:xfrm>
              <a:off x="3047824" y="4341092"/>
              <a:ext cx="3577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10</a:t>
              </a:r>
              <a:endParaRPr lang="en-US" altLang="zh-CN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81" name="直接连接符 80"/>
            <p:cNvCxnSpPr/>
            <p:nvPr/>
          </p:nvCxnSpPr>
          <p:spPr>
            <a:xfrm flipH="1">
              <a:off x="5101432" y="4244239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 flipH="1" flipV="1">
              <a:off x="4960050" y="4140925"/>
              <a:ext cx="144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/>
          </p:nvCxnSpPr>
          <p:spPr>
            <a:xfrm flipH="1">
              <a:off x="5103813" y="4182326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83"/>
            <p:cNvCxnSpPr/>
            <p:nvPr/>
          </p:nvCxnSpPr>
          <p:spPr>
            <a:xfrm flipH="1" flipV="1">
              <a:off x="4964813" y="4074250"/>
              <a:ext cx="14400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0D3E8CD4-04E1-FC41-B15C-07F8FCB80153}"/>
                </a:ext>
              </a:extLst>
            </p:cNvPr>
            <p:cNvSpPr txBox="1"/>
            <p:nvPr/>
          </p:nvSpPr>
          <p:spPr>
            <a:xfrm>
              <a:off x="4686844" y="4365788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10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87" name="直接连接符 86"/>
            <p:cNvCxnSpPr/>
            <p:nvPr/>
          </p:nvCxnSpPr>
          <p:spPr>
            <a:xfrm flipH="1">
              <a:off x="5101432" y="4284721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连接符 87"/>
            <p:cNvCxnSpPr/>
            <p:nvPr/>
          </p:nvCxnSpPr>
          <p:spPr>
            <a:xfrm flipH="1">
              <a:off x="5103814" y="4329964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>
            <a:xfrm flipH="1">
              <a:off x="5103814" y="4377589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92"/>
            <p:cNvCxnSpPr/>
            <p:nvPr/>
          </p:nvCxnSpPr>
          <p:spPr>
            <a:xfrm flipH="1">
              <a:off x="4960050" y="4379049"/>
              <a:ext cx="144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0D3E8CD4-04E1-FC41-B15C-07F8FCB80153}"/>
                </a:ext>
              </a:extLst>
            </p:cNvPr>
            <p:cNvSpPr txBox="1"/>
            <p:nvPr/>
          </p:nvSpPr>
          <p:spPr>
            <a:xfrm>
              <a:off x="4686844" y="4284827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47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95" name="直接连接符 94"/>
            <p:cNvCxnSpPr/>
            <p:nvPr/>
          </p:nvCxnSpPr>
          <p:spPr>
            <a:xfrm flipH="1" flipV="1">
              <a:off x="4960051" y="4207600"/>
              <a:ext cx="14400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0D3E8CD4-04E1-FC41-B15C-07F8FCB80153}"/>
                </a:ext>
              </a:extLst>
            </p:cNvPr>
            <p:cNvSpPr txBox="1"/>
            <p:nvPr/>
          </p:nvSpPr>
          <p:spPr>
            <a:xfrm>
              <a:off x="4686844" y="4203864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457200">
                <a:defRPr/>
              </a:pPr>
              <a:r>
                <a:rPr lang="en-US" altLang="zh-CN" sz="800" dirty="0" smtClean="0">
                  <a:solidFill>
                    <a:prstClr val="black"/>
                  </a:solidFill>
                  <a:latin typeface="Arial" panose="020B0604020202090204" pitchFamily="34" charset="0"/>
                  <a:ea typeface="等线" panose="02010600030101010101" pitchFamily="2" charset="-122"/>
                  <a:cs typeface="Arial" panose="020B0604020202090204" pitchFamily="34" charset="0"/>
                </a:rPr>
                <a:t>190</a:t>
              </a:r>
              <a:endParaRPr lang="zh-CN" altLang="en-US" sz="800" dirty="0">
                <a:solidFill>
                  <a:prstClr val="black"/>
                </a:solidFill>
                <a:latin typeface="Arial" panose="020B0604020202090204" pitchFamily="34" charset="0"/>
                <a:ea typeface="等线" panose="02010600030101010101" pitchFamily="2" charset="-122"/>
                <a:cs typeface="Arial" panose="020B0604020202090204" pitchFamily="34" charset="0"/>
              </a:endParaRPr>
            </a:p>
          </p:txBody>
        </p:sp>
        <p:cxnSp>
          <p:nvCxnSpPr>
            <p:cNvPr id="97" name="直接连接符 96"/>
            <p:cNvCxnSpPr/>
            <p:nvPr/>
          </p:nvCxnSpPr>
          <p:spPr>
            <a:xfrm flipH="1">
              <a:off x="5103813" y="4213283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连接符 99"/>
            <p:cNvCxnSpPr/>
            <p:nvPr/>
          </p:nvCxnSpPr>
          <p:spPr>
            <a:xfrm flipH="1">
              <a:off x="4960051" y="4283801"/>
              <a:ext cx="14400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连接符 100"/>
            <p:cNvCxnSpPr/>
            <p:nvPr/>
          </p:nvCxnSpPr>
          <p:spPr>
            <a:xfrm flipH="1">
              <a:off x="4962432" y="4331426"/>
              <a:ext cx="144000" cy="5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780345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组合 71"/>
          <p:cNvGrpSpPr/>
          <p:nvPr/>
        </p:nvGrpSpPr>
        <p:grpSpPr>
          <a:xfrm>
            <a:off x="1719438" y="3343758"/>
            <a:ext cx="2962804" cy="2302028"/>
            <a:chOff x="1719438" y="3343758"/>
            <a:chExt cx="2962804" cy="2302028"/>
          </a:xfrm>
        </p:grpSpPr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7577" y="406487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9958" y="431014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1BB04C6-09AE-7893-DAC2-DD9101F4EC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2659550" y="3412172"/>
              <a:ext cx="1897754" cy="2233614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9AC3A5C5-9677-ABCD-4D76-904B8ADD5876}"/>
                </a:ext>
              </a:extLst>
            </p:cNvPr>
            <p:cNvSpPr txBox="1"/>
            <p:nvPr/>
          </p:nvSpPr>
          <p:spPr>
            <a:xfrm rot="19800000">
              <a:off x="2717723" y="3343758"/>
              <a:ext cx="5806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36D20CB-A5C4-1FB6-657A-D00A25197352}"/>
                </a:ext>
              </a:extLst>
            </p:cNvPr>
            <p:cNvSpPr txBox="1"/>
            <p:nvPr/>
          </p:nvSpPr>
          <p:spPr>
            <a:xfrm rot="19800000">
              <a:off x="3025861" y="339866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DF78E50D-3D61-5A81-AA32-A685F923A1DE}"/>
                </a:ext>
              </a:extLst>
            </p:cNvPr>
            <p:cNvSpPr txBox="1"/>
            <p:nvPr/>
          </p:nvSpPr>
          <p:spPr>
            <a:xfrm rot="19800000">
              <a:off x="3214406" y="33810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2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CE2D5A8-65A8-BFA1-168C-E7146BA18048}"/>
                </a:ext>
              </a:extLst>
            </p:cNvPr>
            <p:cNvSpPr txBox="1"/>
            <p:nvPr/>
          </p:nvSpPr>
          <p:spPr>
            <a:xfrm rot="19800000">
              <a:off x="3473483" y="33810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694F8BC-BC37-6D1D-5118-AE7AF8AECC61}"/>
                </a:ext>
              </a:extLst>
            </p:cNvPr>
            <p:cNvSpPr txBox="1"/>
            <p:nvPr/>
          </p:nvSpPr>
          <p:spPr>
            <a:xfrm rot="19800000">
              <a:off x="3732560" y="33810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6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85891B44-D067-B0F9-9E49-896ACA566142}"/>
                </a:ext>
              </a:extLst>
            </p:cNvPr>
            <p:cNvSpPr txBox="1"/>
            <p:nvPr/>
          </p:nvSpPr>
          <p:spPr>
            <a:xfrm rot="19800000">
              <a:off x="3991637" y="33810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8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19BBAEF-1638-7169-3C93-40DC99E405B2}"/>
                </a:ext>
              </a:extLst>
            </p:cNvPr>
            <p:cNvSpPr txBox="1"/>
            <p:nvPr/>
          </p:nvSpPr>
          <p:spPr>
            <a:xfrm rot="19800000">
              <a:off x="4250714" y="338102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60 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D039664-A15A-DBD3-7E31-F9F4509FBF20}"/>
                </a:ext>
              </a:extLst>
            </p:cNvPr>
            <p:cNvSpPr txBox="1"/>
            <p:nvPr/>
          </p:nvSpPr>
          <p:spPr>
            <a:xfrm>
              <a:off x="2371902" y="376274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2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371902" y="386961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22F5CC1-1CF1-D599-FD53-5F3FA6FE07C2}"/>
                </a:ext>
              </a:extLst>
            </p:cNvPr>
            <p:cNvSpPr txBox="1"/>
            <p:nvPr/>
          </p:nvSpPr>
          <p:spPr>
            <a:xfrm>
              <a:off x="2371902" y="395000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09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88A635C-588D-9C79-6F1D-37C01229ED35}"/>
                </a:ext>
              </a:extLst>
            </p:cNvPr>
            <p:cNvSpPr txBox="1"/>
            <p:nvPr/>
          </p:nvSpPr>
          <p:spPr>
            <a:xfrm>
              <a:off x="2400756" y="491520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C359709C-AA67-3C5B-8E32-5EB6E5F8E379}"/>
                </a:ext>
              </a:extLst>
            </p:cNvPr>
            <p:cNvSpPr txBox="1"/>
            <p:nvPr/>
          </p:nvSpPr>
          <p:spPr>
            <a:xfrm>
              <a:off x="2400756" y="472947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E705595-B6AA-9FFD-3104-806FBC4B1787}"/>
                </a:ext>
              </a:extLst>
            </p:cNvPr>
            <p:cNvSpPr txBox="1"/>
            <p:nvPr/>
          </p:nvSpPr>
          <p:spPr>
            <a:xfrm>
              <a:off x="2115006" y="456317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4B5A38D-3CDB-2DC4-2707-3892B89B5499}"/>
                </a:ext>
              </a:extLst>
            </p:cNvPr>
            <p:cNvSpPr txBox="1"/>
            <p:nvPr/>
          </p:nvSpPr>
          <p:spPr>
            <a:xfrm>
              <a:off x="2400756" y="433673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7577" y="371086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2419349" y="3924300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/>
          </p:nvCxnSpPr>
          <p:spPr>
            <a:xfrm>
              <a:off x="2419349" y="4130675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>
              <a:off x="2419349" y="4148931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/>
          </p:nvCxnSpPr>
          <p:spPr>
            <a:xfrm>
              <a:off x="2416969" y="4168775"/>
              <a:ext cx="36453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7577" y="383231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7577" y="390930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8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57577" y="398867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29"/>
            <p:cNvCxnSpPr/>
            <p:nvPr/>
          </p:nvCxnSpPr>
          <p:spPr>
            <a:xfrm flipH="1" flipV="1">
              <a:off x="2350772" y="3850564"/>
              <a:ext cx="72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 flipH="1" flipV="1">
              <a:off x="2350772" y="3952958"/>
              <a:ext cx="7200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flipH="1" flipV="1">
              <a:off x="2350772" y="4041857"/>
              <a:ext cx="7200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E705595-B6AA-9FFD-3104-806FBC4B1787}"/>
                </a:ext>
              </a:extLst>
            </p:cNvPr>
            <p:cNvSpPr txBox="1"/>
            <p:nvPr/>
          </p:nvSpPr>
          <p:spPr>
            <a:xfrm>
              <a:off x="2115006" y="446475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连接符 36"/>
            <p:cNvCxnSpPr/>
            <p:nvPr/>
          </p:nvCxnSpPr>
          <p:spPr>
            <a:xfrm>
              <a:off x="2416175" y="4489450"/>
              <a:ext cx="3610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 flipV="1">
              <a:off x="2416674" y="4346575"/>
              <a:ext cx="360000" cy="4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60752" y="438475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/>
            <p:cNvCxnSpPr/>
            <p:nvPr/>
          </p:nvCxnSpPr>
          <p:spPr>
            <a:xfrm>
              <a:off x="2422525" y="4543425"/>
              <a:ext cx="35788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>
              <a:off x="2416175" y="4381500"/>
              <a:ext cx="3610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 flipH="1">
              <a:off x="2347597" y="4380789"/>
              <a:ext cx="72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flipH="1">
              <a:off x="2344422" y="4488739"/>
              <a:ext cx="72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47"/>
            <p:cNvCxnSpPr/>
            <p:nvPr/>
          </p:nvCxnSpPr>
          <p:spPr>
            <a:xfrm flipH="1">
              <a:off x="2353947" y="4539539"/>
              <a:ext cx="7200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>
              <a:off x="2419349" y="4196556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>
              <a:off x="2059349" y="4220369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2059349" y="4237038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/>
          </p:nvCxnSpPr>
          <p:spPr>
            <a:xfrm>
              <a:off x="2059349" y="4270375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/>
            <p:cNvCxnSpPr/>
            <p:nvPr/>
          </p:nvCxnSpPr>
          <p:spPr>
            <a:xfrm>
              <a:off x="2419349" y="4298950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 flipH="1">
              <a:off x="2346009" y="4346658"/>
              <a:ext cx="7200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 flipH="1">
              <a:off x="2348390" y="4299033"/>
              <a:ext cx="7200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2062339" y="423156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直接连接符 58"/>
            <p:cNvCxnSpPr/>
            <p:nvPr/>
          </p:nvCxnSpPr>
          <p:spPr>
            <a:xfrm flipH="1" flipV="1">
              <a:off x="2346009" y="4099007"/>
              <a:ext cx="72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连接符 59"/>
            <p:cNvCxnSpPr/>
            <p:nvPr/>
          </p:nvCxnSpPr>
          <p:spPr>
            <a:xfrm flipH="1" flipV="1">
              <a:off x="2346009" y="4177587"/>
              <a:ext cx="72000" cy="1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1721819" y="424347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接连接符 65"/>
            <p:cNvCxnSpPr/>
            <p:nvPr/>
          </p:nvCxnSpPr>
          <p:spPr>
            <a:xfrm flipH="1">
              <a:off x="1988820" y="4236067"/>
              <a:ext cx="7200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连接符 66"/>
            <p:cNvCxnSpPr/>
            <p:nvPr/>
          </p:nvCxnSpPr>
          <p:spPr>
            <a:xfrm flipH="1">
              <a:off x="1991997" y="4267283"/>
              <a:ext cx="7200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1721819" y="416727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直接连接符 69"/>
            <p:cNvCxnSpPr/>
            <p:nvPr/>
          </p:nvCxnSpPr>
          <p:spPr>
            <a:xfrm flipH="1" flipV="1">
              <a:off x="1988821" y="4201399"/>
              <a:ext cx="72000" cy="1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564863FA-DF44-00EC-4FC0-8E5EE6378F7C}"/>
                </a:ext>
              </a:extLst>
            </p:cNvPr>
            <p:cNvSpPr txBox="1"/>
            <p:nvPr/>
          </p:nvSpPr>
          <p:spPr>
            <a:xfrm>
              <a:off x="1719438" y="409107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288516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1937362" y="1830627"/>
            <a:ext cx="3391819" cy="1788873"/>
            <a:chOff x="1937362" y="1830627"/>
            <a:chExt cx="3391819" cy="1788873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55" t="28617" r="13381" b="44467"/>
            <a:stretch/>
          </p:blipFill>
          <p:spPr>
            <a:xfrm rot="60000" flipH="1">
              <a:off x="2088005" y="1830627"/>
              <a:ext cx="3241176" cy="1138329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962" t="41187" r="22853" b="39894"/>
            <a:stretch/>
          </p:blipFill>
          <p:spPr>
            <a:xfrm>
              <a:off x="2262053" y="2819400"/>
              <a:ext cx="2654301" cy="800100"/>
            </a:xfrm>
            <a:custGeom>
              <a:avLst/>
              <a:gdLst>
                <a:gd name="connsiteX0" fmla="*/ 0 w 2006501"/>
                <a:gd name="connsiteY0" fmla="*/ 0 h 272729"/>
                <a:gd name="connsiteX1" fmla="*/ 2006501 w 2006501"/>
                <a:gd name="connsiteY1" fmla="*/ 0 h 272729"/>
                <a:gd name="connsiteX2" fmla="*/ 2006501 w 2006501"/>
                <a:gd name="connsiteY2" fmla="*/ 272729 h 272729"/>
                <a:gd name="connsiteX3" fmla="*/ 0 w 2006501"/>
                <a:gd name="connsiteY3" fmla="*/ 272729 h 2727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006501" h="272729">
                  <a:moveTo>
                    <a:pt x="0" y="0"/>
                  </a:moveTo>
                  <a:lnTo>
                    <a:pt x="2006501" y="0"/>
                  </a:lnTo>
                  <a:lnTo>
                    <a:pt x="2006501" y="272729"/>
                  </a:lnTo>
                  <a:lnTo>
                    <a:pt x="0" y="272729"/>
                  </a:lnTo>
                  <a:close/>
                </a:path>
              </a:pathLst>
            </a:custGeom>
          </p:spPr>
        </p:pic>
        <p:sp>
          <p:nvSpPr>
            <p:cNvPr id="4" name="文本框 3"/>
            <p:cNvSpPr txBox="1"/>
            <p:nvPr/>
          </p:nvSpPr>
          <p:spPr>
            <a:xfrm rot="19800000">
              <a:off x="2469869" y="1951332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 rot="19800000">
              <a:off x="2812325" y="1967362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 rot="19800000">
              <a:off x="3090661" y="1948527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0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ni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 rot="19800000">
              <a:off x="3444338" y="1965359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DA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 rot="19800000">
              <a:off x="3730688" y="1921276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0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ni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N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 rot="19800000">
              <a:off x="4193367" y="1938107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DCN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984651" y="2213731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Bcl-2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937362" y="3286026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4488708" y="329927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 </a:t>
              </a:r>
              <a:r>
                <a:rPr lang="en-US" altLang="zh-CN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504949" y="221373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 </a:t>
              </a:r>
              <a:r>
                <a:rPr lang="en-US" altLang="zh-CN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39600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17</TotalTime>
  <Words>154</Words>
  <Application>Microsoft Office PowerPoint</Application>
  <PresentationFormat>A4 纸张(210x297 毫米)</PresentationFormat>
  <Paragraphs>132</Paragraphs>
  <Slides>5</Slides>
  <Notes>5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Yuwei</dc:creator>
  <cp:lastModifiedBy>唐建普</cp:lastModifiedBy>
  <cp:revision>200</cp:revision>
  <dcterms:created xsi:type="dcterms:W3CDTF">2021-12-16T02:16:07Z</dcterms:created>
  <dcterms:modified xsi:type="dcterms:W3CDTF">2022-12-03T12:36:55Z</dcterms:modified>
</cp:coreProperties>
</file>